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D62B49C-7674-45A5-94AC-42F59BDD2F79}" v="2" dt="2023-06-09T19:19:23.82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97" d="100"/>
          <a:sy n="97" d="100"/>
        </p:scale>
        <p:origin x="96" y="1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Hanlie Moolman" userId="b57213b6f2b4b731" providerId="LiveId" clId="{6D62B49C-7674-45A5-94AC-42F59BDD2F79}"/>
    <pc:docChg chg="modSld">
      <pc:chgData name="Hanlie Moolman" userId="b57213b6f2b4b731" providerId="LiveId" clId="{6D62B49C-7674-45A5-94AC-42F59BDD2F79}" dt="2023-06-09T19:20:15.656" v="47" actId="207"/>
      <pc:docMkLst>
        <pc:docMk/>
      </pc:docMkLst>
      <pc:sldChg chg="modSp mod">
        <pc:chgData name="Hanlie Moolman" userId="b57213b6f2b4b731" providerId="LiveId" clId="{6D62B49C-7674-45A5-94AC-42F59BDD2F79}" dt="2023-06-09T19:20:15.656" v="47" actId="207"/>
        <pc:sldMkLst>
          <pc:docMk/>
          <pc:sldMk cId="3304532668" sldId="258"/>
        </pc:sldMkLst>
        <pc:spChg chg="mod">
          <ac:chgData name="Hanlie Moolman" userId="b57213b6f2b4b731" providerId="LiveId" clId="{6D62B49C-7674-45A5-94AC-42F59BDD2F79}" dt="2023-06-09T19:20:15.656" v="47" actId="207"/>
          <ac:spMkLst>
            <pc:docMk/>
            <pc:sldMk cId="3304532668" sldId="258"/>
            <ac:spMk id="7" creationId="{304D5077-2B00-A40D-761F-8F661108632C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394F5B2-7481-4B12-6942-E84C7ECB405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777AB776-EB1C-2EE0-AE10-FA21753E091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86FF1BC-00A6-CFC4-EC6E-1312F2B6AD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7AF0AB-17D8-446E-9BC4-7082031D5A49}" type="datetimeFigureOut">
              <a:rPr kumimoji="1" lang="ja-JP" altLang="en-US" smtClean="0"/>
              <a:t>2023/6/1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70F05B4-CFD7-D015-6A00-F23A479D60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090DC4C-4CC6-C1EE-847A-BAD28DF17F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F9BBD8-E763-4F66-8A48-A125DDECE6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59362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E455838-56A1-7B51-12FB-9848BE25E6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58844432-ACF5-1CBB-E945-4FB1B6598AF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A20BCDD-0DF7-553B-47D9-8316349A3C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7AF0AB-17D8-446E-9BC4-7082031D5A49}" type="datetimeFigureOut">
              <a:rPr kumimoji="1" lang="ja-JP" altLang="en-US" smtClean="0"/>
              <a:t>2023/6/1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8C52ACD-DD72-93F2-CFD5-225A8CF65B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4A3C550-C249-C4DB-5022-9B68BF9441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F9BBD8-E763-4F66-8A48-A125DDECE6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147384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DCE4CD99-FD9F-8F48-4668-622680CBD47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8B1AC830-F352-9461-FABE-AA1EEF5155C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EE85088-C484-E6D3-A7AD-539D0736CB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7AF0AB-17D8-446E-9BC4-7082031D5A49}" type="datetimeFigureOut">
              <a:rPr kumimoji="1" lang="ja-JP" altLang="en-US" smtClean="0"/>
              <a:t>2023/6/1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7BD6122-9C46-0142-0682-17D3AAA8F5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676E35B-2F8F-3359-2378-8F0EC52FE3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F9BBD8-E763-4F66-8A48-A125DDECE6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849396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52406F5-0B97-BC05-F8F4-54C07DCBDA5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C0A506B-227C-890E-74D6-A482721F720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36B9D0D-7FBE-44A1-E987-25C811AE1B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7AF0AB-17D8-446E-9BC4-7082031D5A49}" type="datetimeFigureOut">
              <a:rPr kumimoji="1" lang="ja-JP" altLang="en-US" smtClean="0"/>
              <a:t>2023/6/1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0BA6241-A950-13E0-FE7F-3D42D42677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F326BF3-EF14-FA43-998A-08098B837D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F9BBD8-E763-4F66-8A48-A125DDECE6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899276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579D7F3-55F2-D1E3-6E5B-924124C21B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45D94111-CDCA-84DF-0630-7F7DC275213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DF53BD6-AC36-CF93-CD08-52FA8059ED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7AF0AB-17D8-446E-9BC4-7082031D5A49}" type="datetimeFigureOut">
              <a:rPr kumimoji="1" lang="ja-JP" altLang="en-US" smtClean="0"/>
              <a:t>2023/6/1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C5D6C6E-2AB6-C5BF-D7D4-5D3F693273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3A6AF88-CC28-4A18-CC37-083C73B6EC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F9BBD8-E763-4F66-8A48-A125DDECE6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758830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C12F1B4-0185-9B02-2FCC-500DFABA6FF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B9497BB2-B3F7-7033-7318-FB3BE558DAA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A7915455-7837-F28A-410B-4C603BA0A56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18A3D112-80F4-AF02-BCE3-90929F7D25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7AF0AB-17D8-446E-9BC4-7082031D5A49}" type="datetimeFigureOut">
              <a:rPr kumimoji="1" lang="ja-JP" altLang="en-US" smtClean="0"/>
              <a:t>2023/6/1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0BCAE02B-F78C-BEE7-BE6E-42099E08EB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DD2CF93C-3D72-F0C4-0C32-A17A583407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F9BBD8-E763-4F66-8A48-A125DDECE6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155336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6CAF7B4-963F-421D-FA3B-23FC70EF3A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6D1BF770-3A3C-3431-DF0A-FA487F6D9F9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67A858F6-C8F2-A360-B3A7-FCEAC058D1D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5291669C-CF47-37E1-36B1-A18278FAEBF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9D3EF070-8B1B-2237-59A4-E390CEEF29D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F7F92BB6-BE42-FDC1-B0A5-D27E2ECDB9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7AF0AB-17D8-446E-9BC4-7082031D5A49}" type="datetimeFigureOut">
              <a:rPr kumimoji="1" lang="ja-JP" altLang="en-US" smtClean="0"/>
              <a:t>2023/6/10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85F0F1F4-B007-43A2-4C2C-D8049A32CF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D4816460-153C-5661-3873-0E00741D62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F9BBD8-E763-4F66-8A48-A125DDECE6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900788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BAE9307-5DB9-D767-0350-39470A6283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907FC65B-E6B7-5A02-B6CF-B2A439B9FD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7AF0AB-17D8-446E-9BC4-7082031D5A49}" type="datetimeFigureOut">
              <a:rPr kumimoji="1" lang="ja-JP" altLang="en-US" smtClean="0"/>
              <a:t>2023/6/10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4E860429-5387-6883-E272-66E5FF2429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DBFD8936-F79D-8746-A9FE-26188FFAFC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F9BBD8-E763-4F66-8A48-A125DDECE6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707673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03BF2798-B377-36B3-9256-074063ACE2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7AF0AB-17D8-446E-9BC4-7082031D5A49}" type="datetimeFigureOut">
              <a:rPr kumimoji="1" lang="ja-JP" altLang="en-US" smtClean="0"/>
              <a:t>2023/6/10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19503976-DEF7-974E-7D0C-E86E719024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DF0EADC8-49F7-9157-1BE4-D9AF0290A5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F9BBD8-E763-4F66-8A48-A125DDECE6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648514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041CEE8-8F54-5D7A-E205-6C56EDE93E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7D1B6B3-6BF6-6EA7-AF67-75E95EC366C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3C0E6618-FE7F-306B-B94B-C31124E75CC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6E401BE6-EA08-A527-4E27-D4A6603BD5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7AF0AB-17D8-446E-9BC4-7082031D5A49}" type="datetimeFigureOut">
              <a:rPr kumimoji="1" lang="ja-JP" altLang="en-US" smtClean="0"/>
              <a:t>2023/6/1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70A7F570-B520-F247-E4D8-C84DB21D62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19A54643-FF0F-F97B-F3C5-A7D66510DE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F9BBD8-E763-4F66-8A48-A125DDECE6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560164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ABEBA5A-4386-58B8-757E-E1BF3300124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C29352BF-BE44-84B2-D17B-6505FA30427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E9C29A82-7EBA-E97B-E666-E7AABAB3E7B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50A22EE2-E35A-113E-6802-462FD2C835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7AF0AB-17D8-446E-9BC4-7082031D5A49}" type="datetimeFigureOut">
              <a:rPr kumimoji="1" lang="ja-JP" altLang="en-US" smtClean="0"/>
              <a:t>2023/6/1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85E2B21-3B70-FD53-BEE6-28470A360B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14A080E9-A032-3840-E24C-2C5518672F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F9BBD8-E763-4F66-8A48-A125DDECE6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432090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72887A79-9B7F-6ADC-4B71-6F1B39886E5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241BBED3-67C7-F6F4-7FB0-F0DD1216274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6240562-A000-E922-A867-49907827582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7AF0AB-17D8-446E-9BC4-7082031D5A49}" type="datetimeFigureOut">
              <a:rPr kumimoji="1" lang="ja-JP" altLang="en-US" smtClean="0"/>
              <a:t>2023/6/1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4C3E6EE-0322-9F85-7C90-8B1B9F3CE53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00367D1-CFFE-A06D-DCC7-577906608D5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F9BBD8-E763-4F66-8A48-A125DDECE6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863359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図 7">
            <a:extLst>
              <a:ext uri="{FF2B5EF4-FFF2-40B4-BE49-F238E27FC236}">
                <a16:creationId xmlns:a16="http://schemas.microsoft.com/office/drawing/2014/main" id="{678EDB83-AAE7-64FC-D7A2-784A4B74529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84323" y="451383"/>
            <a:ext cx="4843464" cy="4843464"/>
          </a:xfrm>
          <a:prstGeom prst="rect">
            <a:avLst/>
          </a:prstGeom>
        </p:spPr>
      </p:pic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EE566226-BD55-3E50-4C81-7D1E1FE58AD6}"/>
              </a:ext>
            </a:extLst>
          </p:cNvPr>
          <p:cNvSpPr txBox="1"/>
          <p:nvPr/>
        </p:nvSpPr>
        <p:spPr>
          <a:xfrm>
            <a:off x="6096000" y="3301799"/>
            <a:ext cx="1634980" cy="55399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200" dirty="0"/>
              <a:t>AUC</a:t>
            </a:r>
            <a:r>
              <a:rPr lang="ja-JP" altLang="en-US" sz="1200" dirty="0"/>
              <a:t> 0.659 </a:t>
            </a:r>
            <a:endParaRPr lang="en-US" altLang="ja-JP" sz="1200" dirty="0"/>
          </a:p>
          <a:p>
            <a:r>
              <a:rPr lang="ja-JP" altLang="en-US" sz="1200" dirty="0"/>
              <a:t>95%</a:t>
            </a:r>
            <a:r>
              <a:rPr lang="en-US" altLang="ja-JP" sz="1200" dirty="0"/>
              <a:t>CI</a:t>
            </a:r>
            <a:r>
              <a:rPr lang="ja-JP" altLang="en-US" sz="1200" dirty="0"/>
              <a:t> 0.46 - 0.858</a:t>
            </a:r>
            <a:r>
              <a:rPr lang="ja-JP" altLang="en-US" dirty="0"/>
              <a:t> </a:t>
            </a: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258E4E93-A0B0-6721-5B6F-DCC3C8A2241F}"/>
              </a:ext>
            </a:extLst>
          </p:cNvPr>
          <p:cNvSpPr txBox="1"/>
          <p:nvPr/>
        </p:nvSpPr>
        <p:spPr>
          <a:xfrm>
            <a:off x="3747055" y="143606"/>
            <a:ext cx="235352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upplementary Figure S1 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304D5077-2B00-A40D-761F-8F661108632C}"/>
              </a:ext>
            </a:extLst>
          </p:cNvPr>
          <p:cNvSpPr txBox="1"/>
          <p:nvPr/>
        </p:nvSpPr>
        <p:spPr>
          <a:xfrm>
            <a:off x="3967993" y="5368040"/>
            <a:ext cx="411899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1; </a:t>
            </a:r>
          </a:p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ROC curve analysis for</a:t>
            </a:r>
            <a:r>
              <a:rPr lang="ja-JP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occurrence</a:t>
            </a:r>
            <a:r>
              <a:rPr lang="ja-JP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of grade ≥ 2 appetite loss during lenvatinib-treatment for unresectable hepatocellular carcinoma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045326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2</TotalTime>
  <Words>30</Words>
  <Application>Microsoft Office PowerPoint</Application>
  <PresentationFormat>ワイド画面</PresentationFormat>
  <Paragraphs>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游ゴシック</vt:lpstr>
      <vt:lpstr>游ゴシック Light</vt:lpstr>
      <vt:lpstr>Arial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uda goki</dc:creator>
  <cp:lastModifiedBy>須田 剛生</cp:lastModifiedBy>
  <cp:revision>3</cp:revision>
  <dcterms:created xsi:type="dcterms:W3CDTF">2023-06-08T05:47:52Z</dcterms:created>
  <dcterms:modified xsi:type="dcterms:W3CDTF">2023-06-10T14:32:08Z</dcterms:modified>
</cp:coreProperties>
</file>